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195" autoAdjust="0"/>
    <p:restoredTop sz="94660"/>
  </p:normalViewPr>
  <p:slideViewPr>
    <p:cSldViewPr snapToGrid="0">
      <p:cViewPr varScale="1">
        <p:scale>
          <a:sx n="137" d="100"/>
          <a:sy n="137" d="100"/>
        </p:scale>
        <p:origin x="208" y="3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D40D9F-13A3-452A-93A3-0C8F07F334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2C1576D-3B61-4F3D-A784-E5675D096F1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42674B2-3151-48C2-8079-A7259C6180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62B-2937-4357-9429-E8205F7E3FBC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67C322-FA60-4A42-B2E0-518FB9D0C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27A33F-FCE2-4411-8307-E4D85B3DC0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03A1D-A6E1-45D8-AE36-B258D617D5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77079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9BEEF8-857E-49E4-9E0E-F1761C2DFA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8DEF0D3-26D0-4A34-A896-8349D74098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D2E29A-C8EB-44F4-B1A6-2C02F141F7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62B-2937-4357-9429-E8205F7E3FBC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3C3B9A-AF3D-4740-BB2D-6D24623EA3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9B9443-9AE7-4929-BD4E-0B337E9F5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03A1D-A6E1-45D8-AE36-B258D617D5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13440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9E9746C-2632-4329-8FD0-936F9DBC8C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94E763-1094-491D-8985-7CF54D075E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FE0468-DD0D-41DD-BF78-E1F011915F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62B-2937-4357-9429-E8205F7E3FBC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559CB9-8705-47B9-8E95-5D0142C05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9D8445-679A-4C16-B7F9-2FBDBFE1BF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03A1D-A6E1-45D8-AE36-B258D617D5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2080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4B90E7-E76A-47F1-A2A9-947D29FE68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06551E-E5B3-449A-8C76-1E622742D4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2FEBC9-3937-4AFE-A17F-EDEF2228D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62B-2937-4357-9429-E8205F7E3FBC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32CF7A-E234-4232-9BA1-9A4A6AEFC0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A5A441-3905-4EA4-822A-96CFE54FAF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03A1D-A6E1-45D8-AE36-B258D617D5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79121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63B923-100D-4C7E-9BB0-6BBF6E7A04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738B97-6E27-43F9-853A-BDA7666420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15590F-49C0-4DDD-B7D8-5EB5DE178E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62B-2937-4357-9429-E8205F7E3FBC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13AFFD-CC41-47F4-BD7F-E44EB00D10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B08B50-FB57-49D1-BF6A-7AD313AF4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03A1D-A6E1-45D8-AE36-B258D617D5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49178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5695E6-B837-4426-AA34-28039CB0C0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3CA09F-1AAF-44A1-8C2A-973C27D967D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2F76129-F68D-46A3-A29D-227371BB5DF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1032986-8D85-47A6-B8DF-6415BA8A00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62B-2937-4357-9429-E8205F7E3FBC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D1AE7D-054C-4959-BD20-B31223C29F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DBFA75-3BF6-4B7C-A4BB-8004BE31D9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03A1D-A6E1-45D8-AE36-B258D617D5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93746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E0E007-38A0-435F-9C0B-1811E385C1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A301F3-6889-44F6-AB04-36ABAA3FC0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EBF135-3706-4BE6-8E84-5D6F083E8D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DC3D086-B101-4F63-8723-A0F0428B582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CBF6C19-04E2-4589-AB89-0E31DD1A3DA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F4DA0DA-891F-41B4-ACA5-DE856AE506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62B-2937-4357-9429-E8205F7E3FBC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25164FC-9B46-44CD-BDA0-D870DA35A0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41D079-5C71-439E-9883-C540D6821E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03A1D-A6E1-45D8-AE36-B258D617D5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6618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D8DDEA-DCC7-444E-85BC-A78AF327B9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E77D16B-4DB5-4666-AC95-EB8064782E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62B-2937-4357-9429-E8205F7E3FBC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872F779-EFBA-483E-AE9D-36BD352DCD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5547133-13F1-4EC0-8121-C1D1D6EBFA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03A1D-A6E1-45D8-AE36-B258D617D5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87066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7FB5731-EC07-42B7-A9AB-8A7CF747EF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62B-2937-4357-9429-E8205F7E3FBC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A6EAB90-46C6-464A-82D6-DE14784E15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8429E82-A229-4DC8-8BFE-33D40A7397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03A1D-A6E1-45D8-AE36-B258D617D5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57405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27C97B-F440-499E-9F32-C38BAD7388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3EDA95-1F4B-48B1-B69F-5D1C46F08D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44C1882-5F36-4F87-8241-2D5E1C45D8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0753E2-0E85-49D1-BEB7-0A88620CD8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62B-2937-4357-9429-E8205F7E3FBC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26F13B-FE21-4265-9CB2-DB1C12100F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B26DAA0-E1C5-4887-BCAC-53466429EB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03A1D-A6E1-45D8-AE36-B258D617D5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99361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5388D0-FE5C-4359-8DEE-87B32656CE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3A460BD-F3A7-489B-9DD4-F149AE8A48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80F5F85-E897-4DD9-9F2F-002EE0AE76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C358960-AB25-4E5A-A1C4-63574584A4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12B62B-2937-4357-9429-E8205F7E3FBC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032B93-F81F-40E4-BACC-DDA7AF96B4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4BE25A-8614-44B4-8E0E-3354DB8968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03A1D-A6E1-45D8-AE36-B258D617D5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4834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7214F85-776E-4092-A152-9D70383237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B4C0DCE-9C12-455B-8F87-D7F1A8CCF3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085FD3-87E9-4EF6-9246-9282CB32A4A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12B62B-2937-4357-9429-E8205F7E3FBC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93A955-95E3-4609-99E7-B906BC930A4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F53CEB-8A90-425D-B7C1-F342BA71EC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C03A1D-A6E1-45D8-AE36-B258D617D5E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04629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scatter chart&#10;&#10;Description automatically generated">
            <a:extLst>
              <a:ext uri="{FF2B5EF4-FFF2-40B4-BE49-F238E27FC236}">
                <a16:creationId xmlns:a16="http://schemas.microsoft.com/office/drawing/2014/main" id="{1EC6BD07-FF0F-416D-A8D0-591A30FA4F7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804"/>
          <a:stretch/>
        </p:blipFill>
        <p:spPr>
          <a:xfrm>
            <a:off x="5578592" y="398103"/>
            <a:ext cx="6190772" cy="5051498"/>
          </a:xfrm>
          <a:prstGeom prst="rect">
            <a:avLst/>
          </a:prstGeom>
        </p:spPr>
      </p:pic>
      <p:pic>
        <p:nvPicPr>
          <p:cNvPr id="7" name="Picture 6" descr="Chart, scatter chart&#10;&#10;Description automatically generated">
            <a:extLst>
              <a:ext uri="{FF2B5EF4-FFF2-40B4-BE49-F238E27FC236}">
                <a16:creationId xmlns:a16="http://schemas.microsoft.com/office/drawing/2014/main" id="{9A890A09-FD5D-4EF6-B1CD-E52D139792E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510" r="26755"/>
          <a:stretch/>
        </p:blipFill>
        <p:spPr>
          <a:xfrm>
            <a:off x="422636" y="398103"/>
            <a:ext cx="4688263" cy="5238946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C961B5E-F99A-48D9-8584-D19E7BD44BE4}"/>
              </a:ext>
            </a:extLst>
          </p:cNvPr>
          <p:cNvSpPr txBox="1"/>
          <p:nvPr/>
        </p:nvSpPr>
        <p:spPr>
          <a:xfrm>
            <a:off x="754144" y="5735637"/>
            <a:ext cx="1132283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10: </a:t>
            </a:r>
            <a:r>
              <a:rPr lang="en-US" sz="1200" dirty="0"/>
              <a:t>Principal Component Analysis (PCA) of PI251246 (blue) and Armenian </a:t>
            </a:r>
            <a:r>
              <a:rPr lang="en-US" sz="1200" i="1" dirty="0"/>
              <a:t>L. </a:t>
            </a:r>
            <a:r>
              <a:rPr lang="en-US" sz="1200" i="1" dirty="0" err="1"/>
              <a:t>serriola</a:t>
            </a:r>
            <a:r>
              <a:rPr lang="en-US" sz="1200" i="1" dirty="0"/>
              <a:t> </a:t>
            </a:r>
            <a:r>
              <a:rPr lang="en-US" sz="1200" dirty="0"/>
              <a:t>(pink) </a:t>
            </a:r>
            <a:r>
              <a:rPr lang="en-US" sz="1200" dirty="0" err="1"/>
              <a:t>RNAseq</a:t>
            </a:r>
            <a:r>
              <a:rPr lang="en-US" sz="1200" dirty="0"/>
              <a:t> data after pathogen infection with (A) </a:t>
            </a:r>
            <a:r>
              <a:rPr lang="en-US" sz="1200" i="1" dirty="0"/>
              <a:t>B. cinerea </a:t>
            </a:r>
            <a:r>
              <a:rPr lang="en-US" sz="1200" dirty="0"/>
              <a:t>and (B) </a:t>
            </a:r>
            <a:r>
              <a:rPr lang="en-US" sz="1200" i="1" dirty="0"/>
              <a:t>S. </a:t>
            </a:r>
            <a:r>
              <a:rPr lang="en-US" sz="1200" i="1" dirty="0" err="1"/>
              <a:t>sclerotiorum</a:t>
            </a:r>
            <a:r>
              <a:rPr lang="en-US" sz="1200" i="1" dirty="0"/>
              <a:t>. </a:t>
            </a:r>
            <a:r>
              <a:rPr lang="en-US" sz="1200" dirty="0"/>
              <a:t>The PCA plot shows two independent experiments: Diversity Set </a:t>
            </a:r>
            <a:r>
              <a:rPr lang="en-US" sz="1200" dirty="0" err="1"/>
              <a:t>RNAseq</a:t>
            </a:r>
            <a:r>
              <a:rPr lang="en-US" sz="1200" dirty="0"/>
              <a:t> (circles) and the mapping population parent repeat (triangles). In </a:t>
            </a:r>
            <a:r>
              <a:rPr lang="en-US" sz="1200" i="1" dirty="0"/>
              <a:t>S. </a:t>
            </a:r>
            <a:r>
              <a:rPr lang="en-US" sz="1200" i="1" dirty="0" err="1"/>
              <a:t>sclerotiorum</a:t>
            </a:r>
            <a:r>
              <a:rPr lang="en-US" sz="1200" i="1" dirty="0"/>
              <a:t> </a:t>
            </a:r>
            <a:r>
              <a:rPr lang="en-US" sz="1200" dirty="0"/>
              <a:t>infected samples</a:t>
            </a:r>
            <a:r>
              <a:rPr lang="en-US" sz="1200" i="1" dirty="0"/>
              <a:t>, </a:t>
            </a:r>
            <a:r>
              <a:rPr lang="en-US" sz="1200" dirty="0"/>
              <a:t>there is a clear separation across PC1 between the parental lines that is consistent across experiments. In </a:t>
            </a:r>
            <a:r>
              <a:rPr lang="en-US" sz="1200" i="1" dirty="0"/>
              <a:t>B. cinerea</a:t>
            </a:r>
            <a:r>
              <a:rPr lang="en-US" sz="1200" dirty="0"/>
              <a:t> infected samples, the largest separation across PC1 appears to reflect different experiments, but each parent line clearly separates within the experiment across PC2. </a:t>
            </a:r>
            <a:endParaRPr lang="en-GB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0F79F25-4832-445F-83AE-36AA096C7E06}"/>
              </a:ext>
            </a:extLst>
          </p:cNvPr>
          <p:cNvSpPr txBox="1"/>
          <p:nvPr/>
        </p:nvSpPr>
        <p:spPr>
          <a:xfrm>
            <a:off x="394103" y="299515"/>
            <a:ext cx="5938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5D65820-8CB6-48CE-BCA4-42B517F14A0D}"/>
              </a:ext>
            </a:extLst>
          </p:cNvPr>
          <p:cNvSpPr txBox="1"/>
          <p:nvPr/>
        </p:nvSpPr>
        <p:spPr>
          <a:xfrm>
            <a:off x="5281648" y="275194"/>
            <a:ext cx="5938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)</a:t>
            </a:r>
          </a:p>
        </p:txBody>
      </p:sp>
    </p:spTree>
    <p:extLst>
      <p:ext uri="{BB962C8B-B14F-4D97-AF65-F5344CB8AC3E}">
        <p14:creationId xmlns:p14="http://schemas.microsoft.com/office/powerpoint/2010/main" val="14315558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124</Words>
  <Application>Microsoft Macintosh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ry Pink</dc:creator>
  <cp:lastModifiedBy>Katherine Denby</cp:lastModifiedBy>
  <cp:revision>5</cp:revision>
  <dcterms:created xsi:type="dcterms:W3CDTF">2022-01-19T16:34:51Z</dcterms:created>
  <dcterms:modified xsi:type="dcterms:W3CDTF">2022-02-20T16:13:55Z</dcterms:modified>
</cp:coreProperties>
</file>